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he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5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25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fs01\users\nathalia\first%20paper\validation\rt%20calculation%20version2019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400" b="1" i="0" baseline="0">
                <a:solidFill>
                  <a:sysClr val="windowText" lastClr="000000"/>
                </a:solidFill>
                <a:effectLst/>
              </a:rPr>
              <a:t>Differentially Expressed Genes</a:t>
            </a:r>
            <a:endParaRPr lang="he-IL" sz="1400" b="1">
              <a:solidFill>
                <a:sysClr val="windowText" lastClr="000000"/>
              </a:solidFill>
              <a:effectLst/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he-IL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3:$A$9</c:f>
              <c:strCache>
                <c:ptCount val="7"/>
                <c:pt idx="0">
                  <c:v>Protoplast1</c:v>
                </c:pt>
                <c:pt idx="1">
                  <c:v>9-HOT1</c:v>
                </c:pt>
                <c:pt idx="2">
                  <c:v>9-HOT2</c:v>
                </c:pt>
                <c:pt idx="3">
                  <c:v>9-HOT3</c:v>
                </c:pt>
                <c:pt idx="4">
                  <c:v>9-HOT4</c:v>
                </c:pt>
                <c:pt idx="5">
                  <c:v>9-HOT5</c:v>
                </c:pt>
                <c:pt idx="6">
                  <c:v>9-HOT6</c:v>
                </c:pt>
              </c:strCache>
            </c:strRef>
          </c:cat>
          <c:val>
            <c:numRef>
              <c:f>Sheet1!$B$3:$B$9</c:f>
              <c:numCache>
                <c:formatCode>General</c:formatCode>
                <c:ptCount val="7"/>
                <c:pt idx="0">
                  <c:v>-4.479853162632141</c:v>
                </c:pt>
                <c:pt idx="1">
                  <c:v>-7.6037298235586306</c:v>
                </c:pt>
                <c:pt idx="2">
                  <c:v>-4.3310176037525192</c:v>
                </c:pt>
                <c:pt idx="3">
                  <c:v>-15.464098593024978</c:v>
                </c:pt>
                <c:pt idx="4">
                  <c:v>0.32169451481465006</c:v>
                </c:pt>
                <c:pt idx="5">
                  <c:v>6.023305787122208</c:v>
                </c:pt>
                <c:pt idx="6">
                  <c:v>0.33866129887344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3DB-498C-A910-70F4C479E8B4}"/>
            </c:ext>
          </c:extLst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RNA-Seq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3:$A$9</c:f>
              <c:strCache>
                <c:ptCount val="7"/>
                <c:pt idx="0">
                  <c:v>Protoplast1</c:v>
                </c:pt>
                <c:pt idx="1">
                  <c:v>9-HOT1</c:v>
                </c:pt>
                <c:pt idx="2">
                  <c:v>9-HOT2</c:v>
                </c:pt>
                <c:pt idx="3">
                  <c:v>9-HOT3</c:v>
                </c:pt>
                <c:pt idx="4">
                  <c:v>9-HOT4</c:v>
                </c:pt>
                <c:pt idx="5">
                  <c:v>9-HOT5</c:v>
                </c:pt>
                <c:pt idx="6">
                  <c:v>9-HOT6</c:v>
                </c:pt>
              </c:strCache>
            </c:strRef>
          </c:cat>
          <c:val>
            <c:numRef>
              <c:f>Sheet1!$C$3:$C$9</c:f>
              <c:numCache>
                <c:formatCode>General</c:formatCode>
                <c:ptCount val="7"/>
                <c:pt idx="0">
                  <c:v>-1.8666809007283403</c:v>
                </c:pt>
                <c:pt idx="1">
                  <c:v>-2.6234583235210636</c:v>
                </c:pt>
                <c:pt idx="2">
                  <c:v>-3.6198853376504831</c:v>
                </c:pt>
                <c:pt idx="3">
                  <c:v>-2.1459820633134123</c:v>
                </c:pt>
                <c:pt idx="4">
                  <c:v>3.2428521693245291</c:v>
                </c:pt>
                <c:pt idx="5">
                  <c:v>3.0111466785250487</c:v>
                </c:pt>
                <c:pt idx="6">
                  <c:v>5.2597382866228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3DB-498C-A910-70F4C479E8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6605904"/>
        <c:axId val="336607472"/>
      </c:barChart>
      <c:catAx>
        <c:axId val="3366059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336607472"/>
        <c:crosses val="autoZero"/>
        <c:auto val="0"/>
        <c:lblAlgn val="ctr"/>
        <c:lblOffset val="100"/>
        <c:noMultiLvlLbl val="0"/>
      </c:catAx>
      <c:valAx>
        <c:axId val="3366074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 i="0" baseline="0" dirty="0">
                    <a:solidFill>
                      <a:sysClr val="windowText" lastClr="000000"/>
                    </a:solidFill>
                    <a:effectLst/>
                  </a:rPr>
                  <a:t>Relative Expression Level (FC</a:t>
                </a:r>
                <a:r>
                  <a:rPr lang="en-US" sz="1200" b="1" i="0" baseline="0" dirty="0" smtClean="0">
                    <a:solidFill>
                      <a:sysClr val="windowText" lastClr="000000"/>
                    </a:solidFill>
                    <a:effectLst/>
                  </a:rPr>
                  <a:t>)</a:t>
                </a:r>
                <a:endParaRPr lang="he-IL" sz="1200" b="1" dirty="0">
                  <a:solidFill>
                    <a:sysClr val="windowText" lastClr="000000"/>
                  </a:solidFill>
                  <a:effectLst/>
                </a:endParaRPr>
              </a:p>
            </c:rich>
          </c:tx>
          <c:layout>
            <c:manualLayout>
              <c:xMode val="edge"/>
              <c:yMode val="edge"/>
              <c:x val="2.2059731499749085E-2"/>
              <c:y val="0.2679484948529762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2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he-I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3366059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</c:legendEntry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</c:legendEntry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he-IL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he-IL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216C0-DBF5-4A84-B0D8-21EB2E60794D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3A730-9A6D-4EAA-83B0-23B67466A4F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8987333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216C0-DBF5-4A84-B0D8-21EB2E60794D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3A730-9A6D-4EAA-83B0-23B67466A4F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836059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216C0-DBF5-4A84-B0D8-21EB2E60794D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3A730-9A6D-4EAA-83B0-23B67466A4F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910551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216C0-DBF5-4A84-B0D8-21EB2E60794D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3A730-9A6D-4EAA-83B0-23B67466A4F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182562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216C0-DBF5-4A84-B0D8-21EB2E60794D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3A730-9A6D-4EAA-83B0-23B67466A4F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275185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216C0-DBF5-4A84-B0D8-21EB2E60794D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3A730-9A6D-4EAA-83B0-23B67466A4F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548556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216C0-DBF5-4A84-B0D8-21EB2E60794D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3A730-9A6D-4EAA-83B0-23B67466A4F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674301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216C0-DBF5-4A84-B0D8-21EB2E60794D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3A730-9A6D-4EAA-83B0-23B67466A4F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275560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216C0-DBF5-4A84-B0D8-21EB2E60794D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3A730-9A6D-4EAA-83B0-23B67466A4F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1739477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216C0-DBF5-4A84-B0D8-21EB2E60794D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3A730-9A6D-4EAA-83B0-23B67466A4F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679707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216C0-DBF5-4A84-B0D8-21EB2E60794D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3A730-9A6D-4EAA-83B0-23B67466A4F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8711113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9216C0-DBF5-4A84-B0D8-21EB2E60794D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23A730-9A6D-4EAA-83B0-23B67466A4F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071197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4" name="Chart 23"/>
          <p:cNvGraphicFramePr>
            <a:graphicFrameLocks/>
          </p:cNvGraphicFramePr>
          <p:nvPr>
            <p:extLst/>
          </p:nvPr>
        </p:nvGraphicFramePr>
        <p:xfrm>
          <a:off x="2262554" y="1167619"/>
          <a:ext cx="7711440" cy="40936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9114692" y="2461852"/>
            <a:ext cx="211016" cy="2813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 smtClean="0"/>
              <a:t>a</a:t>
            </a:r>
            <a:endParaRPr lang="he-IL" sz="1200" dirty="0"/>
          </a:p>
        </p:txBody>
      </p:sp>
      <p:sp>
        <p:nvSpPr>
          <p:cNvPr id="26" name="TextBox 25"/>
          <p:cNvSpPr txBox="1"/>
          <p:nvPr/>
        </p:nvSpPr>
        <p:spPr>
          <a:xfrm>
            <a:off x="8410135" y="2180494"/>
            <a:ext cx="211016" cy="2813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 smtClean="0"/>
              <a:t>a</a:t>
            </a:r>
            <a:endParaRPr lang="he-IL" sz="1200" dirty="0"/>
          </a:p>
        </p:txBody>
      </p:sp>
      <p:sp>
        <p:nvSpPr>
          <p:cNvPr id="27" name="TextBox 26"/>
          <p:cNvSpPr txBox="1"/>
          <p:nvPr/>
        </p:nvSpPr>
        <p:spPr>
          <a:xfrm>
            <a:off x="7141699" y="2457158"/>
            <a:ext cx="211016" cy="2813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 smtClean="0"/>
              <a:t>a</a:t>
            </a:r>
            <a:endParaRPr lang="he-IL" sz="1200" dirty="0"/>
          </a:p>
        </p:txBody>
      </p:sp>
      <p:sp>
        <p:nvSpPr>
          <p:cNvPr id="28" name="TextBox 27"/>
          <p:cNvSpPr txBox="1"/>
          <p:nvPr/>
        </p:nvSpPr>
        <p:spPr>
          <a:xfrm>
            <a:off x="6160478" y="4382086"/>
            <a:ext cx="211016" cy="2813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 smtClean="0"/>
              <a:t>a</a:t>
            </a:r>
            <a:endParaRPr lang="he-IL" sz="1200" dirty="0"/>
          </a:p>
        </p:txBody>
      </p:sp>
      <p:sp>
        <p:nvSpPr>
          <p:cNvPr id="29" name="TextBox 28"/>
          <p:cNvSpPr txBox="1"/>
          <p:nvPr/>
        </p:nvSpPr>
        <p:spPr>
          <a:xfrm>
            <a:off x="5440680" y="3240259"/>
            <a:ext cx="211016" cy="2813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 smtClean="0"/>
              <a:t>a</a:t>
            </a:r>
            <a:endParaRPr lang="he-IL" sz="1200" dirty="0"/>
          </a:p>
        </p:txBody>
      </p:sp>
      <p:sp>
        <p:nvSpPr>
          <p:cNvPr id="30" name="TextBox 29"/>
          <p:cNvSpPr txBox="1"/>
          <p:nvPr/>
        </p:nvSpPr>
        <p:spPr>
          <a:xfrm>
            <a:off x="5165187" y="3305908"/>
            <a:ext cx="211016" cy="2813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 smtClean="0"/>
              <a:t>a</a:t>
            </a:r>
            <a:endParaRPr lang="he-IL" sz="1200" dirty="0"/>
          </a:p>
        </p:txBody>
      </p:sp>
      <p:sp>
        <p:nvSpPr>
          <p:cNvPr id="31" name="TextBox 30"/>
          <p:cNvSpPr txBox="1"/>
          <p:nvPr/>
        </p:nvSpPr>
        <p:spPr>
          <a:xfrm>
            <a:off x="4168726" y="3627120"/>
            <a:ext cx="211016" cy="2813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 smtClean="0"/>
              <a:t>a</a:t>
            </a:r>
            <a:endParaRPr lang="he-IL" sz="1200" dirty="0"/>
          </a:p>
        </p:txBody>
      </p:sp>
      <p:sp>
        <p:nvSpPr>
          <p:cNvPr id="32" name="TextBox 31"/>
          <p:cNvSpPr txBox="1"/>
          <p:nvPr/>
        </p:nvSpPr>
        <p:spPr>
          <a:xfrm>
            <a:off x="3191021" y="3345766"/>
            <a:ext cx="211016" cy="2813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 smtClean="0"/>
              <a:t>a</a:t>
            </a:r>
            <a:endParaRPr lang="he-IL" sz="1200" dirty="0"/>
          </a:p>
        </p:txBody>
      </p:sp>
      <p:sp>
        <p:nvSpPr>
          <p:cNvPr id="34" name="TextBox 33"/>
          <p:cNvSpPr txBox="1"/>
          <p:nvPr/>
        </p:nvSpPr>
        <p:spPr>
          <a:xfrm>
            <a:off x="9396048" y="1978860"/>
            <a:ext cx="218049" cy="2813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 smtClean="0"/>
              <a:t>b</a:t>
            </a:r>
            <a:endParaRPr lang="he-IL" sz="1200" dirty="0"/>
          </a:p>
        </p:txBody>
      </p:sp>
      <p:sp>
        <p:nvSpPr>
          <p:cNvPr id="35" name="TextBox 34"/>
          <p:cNvSpPr txBox="1"/>
          <p:nvPr/>
        </p:nvSpPr>
        <p:spPr>
          <a:xfrm>
            <a:off x="8121746" y="1910863"/>
            <a:ext cx="218049" cy="2813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 smtClean="0"/>
              <a:t>b</a:t>
            </a:r>
            <a:endParaRPr lang="he-IL" sz="1200" dirty="0"/>
          </a:p>
        </p:txBody>
      </p:sp>
      <p:sp>
        <p:nvSpPr>
          <p:cNvPr id="36" name="TextBox 35"/>
          <p:cNvSpPr txBox="1"/>
          <p:nvPr/>
        </p:nvSpPr>
        <p:spPr>
          <a:xfrm>
            <a:off x="7425396" y="2161739"/>
            <a:ext cx="218049" cy="2813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 smtClean="0"/>
              <a:t>b</a:t>
            </a:r>
            <a:endParaRPr lang="he-IL" sz="1200" dirty="0"/>
          </a:p>
        </p:txBody>
      </p:sp>
      <p:sp>
        <p:nvSpPr>
          <p:cNvPr id="37" name="TextBox 36"/>
          <p:cNvSpPr txBox="1"/>
          <p:nvPr/>
        </p:nvSpPr>
        <p:spPr>
          <a:xfrm>
            <a:off x="6441830" y="3113650"/>
            <a:ext cx="218049" cy="2813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 smtClean="0"/>
              <a:t>b</a:t>
            </a:r>
            <a:endParaRPr lang="he-IL" sz="1200" dirty="0"/>
          </a:p>
        </p:txBody>
      </p:sp>
      <p:sp>
        <p:nvSpPr>
          <p:cNvPr id="38" name="TextBox 37"/>
          <p:cNvSpPr txBox="1"/>
          <p:nvPr/>
        </p:nvSpPr>
        <p:spPr>
          <a:xfrm>
            <a:off x="4467664" y="3153510"/>
            <a:ext cx="218049" cy="2813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 smtClean="0"/>
              <a:t>b</a:t>
            </a:r>
            <a:endParaRPr lang="he-IL" sz="1200" dirty="0"/>
          </a:p>
        </p:txBody>
      </p:sp>
      <p:sp>
        <p:nvSpPr>
          <p:cNvPr id="39" name="TextBox 38"/>
          <p:cNvSpPr txBox="1"/>
          <p:nvPr/>
        </p:nvSpPr>
        <p:spPr>
          <a:xfrm>
            <a:off x="3467686" y="3071446"/>
            <a:ext cx="218049" cy="2813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 smtClean="0"/>
              <a:t>b</a:t>
            </a:r>
            <a:endParaRPr lang="he-IL" sz="1200" dirty="0"/>
          </a:p>
        </p:txBody>
      </p:sp>
    </p:spTree>
    <p:extLst>
      <p:ext uri="{BB962C8B-B14F-4D97-AF65-F5344CB8AC3E}">
        <p14:creationId xmlns:p14="http://schemas.microsoft.com/office/powerpoint/2010/main" val="38528513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640080" y="1222629"/>
            <a:ext cx="10449098" cy="39703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3.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Comparison of RNA-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eq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(light gray) and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qRT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PCR (dark gray) expression profiling of the differentially expressed (downregulated and upregulated) genes: Protoplasts#1 and 9-HOT#1–6 were examined by RNA-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eq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qRT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PCR from J2 of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. </a:t>
            </a:r>
            <a:r>
              <a:rPr lang="en-US" i="1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javanica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xposed to protoplasts and 9-HOT treatment, respectively.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ach reaction was performed in triplicate and the results are presented as the mean relative expression and standard error of two independent biological replicates. Different letters above the bars denote a significant difference (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≤ 0.05, analysis of variance) between samples as analyzed by Tukey–Kramer multiple comparison test. The experiment was repeated three times and similar results were obtained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320981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1</Words>
  <Application>Microsoft Office PowerPoint</Application>
  <PresentationFormat>Widescreen</PresentationFormat>
  <Paragraphs>1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>Volcan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gal Brown Miyara</dc:creator>
  <cp:lastModifiedBy>Sigal Brown Miyara</cp:lastModifiedBy>
  <cp:revision>2</cp:revision>
  <dcterms:created xsi:type="dcterms:W3CDTF">2020-09-24T06:51:15Z</dcterms:created>
  <dcterms:modified xsi:type="dcterms:W3CDTF">2020-12-11T21:00:27Z</dcterms:modified>
</cp:coreProperties>
</file>